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5" r:id="rId2"/>
    <p:sldId id="266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0000CC"/>
    <a:srgbClr val="99CC00"/>
    <a:srgbClr val="99FF33"/>
    <a:srgbClr val="CCFF66"/>
    <a:srgbClr val="00CC99"/>
    <a:srgbClr val="00FFCC"/>
    <a:srgbClr val="CC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2856"/>
    <p:restoredTop sz="94671"/>
  </p:normalViewPr>
  <p:slideViewPr>
    <p:cSldViewPr snapToGrid="0">
      <p:cViewPr>
        <p:scale>
          <a:sx n="100" d="100"/>
          <a:sy n="100" d="100"/>
        </p:scale>
        <p:origin x="552" y="-1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946850393700803E-2"/>
          <c:y val="2.0682779235928799E-2"/>
          <c:w val="0.92605314960629903"/>
          <c:h val="0.95863444152814303"/>
        </c:manualLayout>
      </c:layout>
      <c:lineChart>
        <c:grouping val="standard"/>
        <c:varyColors val="0"/>
        <c:ser>
          <c:idx val="0"/>
          <c:order val="0"/>
          <c:tx>
            <c:strRef>
              <c:f>curve!$B$2</c:f>
              <c:strCache>
                <c:ptCount val="1"/>
                <c:pt idx="0">
                  <c:v>1%</c:v>
                </c:pt>
              </c:strCache>
            </c:strRef>
          </c:tx>
          <c:spPr>
            <a:ln w="95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B$3:$B$11</c:f>
              <c:numCache>
                <c:formatCode>0.000</c:formatCode>
                <c:ptCount val="9"/>
                <c:pt idx="0">
                  <c:v>0.62303764711923504</c:v>
                </c:pt>
                <c:pt idx="1">
                  <c:v>0.589839971078292</c:v>
                </c:pt>
                <c:pt idx="2">
                  <c:v>0.593063341038507</c:v>
                </c:pt>
                <c:pt idx="3">
                  <c:v>0.58781216013137505</c:v>
                </c:pt>
                <c:pt idx="4">
                  <c:v>0.58982030420009501</c:v>
                </c:pt>
                <c:pt idx="5">
                  <c:v>0.58167610322399999</c:v>
                </c:pt>
                <c:pt idx="6">
                  <c:v>0.57249024701968998</c:v>
                </c:pt>
                <c:pt idx="7">
                  <c:v>0.55865285413110499</c:v>
                </c:pt>
                <c:pt idx="8">
                  <c:v>0.545641997583608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344-4BDF-9849-72ECE1269FD4}"/>
            </c:ext>
          </c:extLst>
        </c:ser>
        <c:ser>
          <c:idx val="1"/>
          <c:order val="1"/>
          <c:tx>
            <c:strRef>
              <c:f>curve!$C$2</c:f>
              <c:strCache>
                <c:ptCount val="1"/>
                <c:pt idx="0">
                  <c:v>5%</c:v>
                </c:pt>
              </c:strCache>
            </c:strRef>
          </c:tx>
          <c:spPr>
            <a:ln w="952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C$3:$C$11</c:f>
              <c:numCache>
                <c:formatCode>0.000</c:formatCode>
                <c:ptCount val="9"/>
                <c:pt idx="0">
                  <c:v>0.33450721255138499</c:v>
                </c:pt>
                <c:pt idx="1">
                  <c:v>0.31937822121356602</c:v>
                </c:pt>
                <c:pt idx="2">
                  <c:v>0.32003908721563901</c:v>
                </c:pt>
                <c:pt idx="3">
                  <c:v>0.31279050166617101</c:v>
                </c:pt>
                <c:pt idx="4">
                  <c:v>0.30948033170174499</c:v>
                </c:pt>
                <c:pt idx="5">
                  <c:v>0.299799476133432</c:v>
                </c:pt>
                <c:pt idx="6">
                  <c:v>0.29183092884519402</c:v>
                </c:pt>
                <c:pt idx="7">
                  <c:v>0.28206382243731198</c:v>
                </c:pt>
                <c:pt idx="8">
                  <c:v>0.273020962296438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344-4BDF-9849-72ECE1269FD4}"/>
            </c:ext>
          </c:extLst>
        </c:ser>
        <c:ser>
          <c:idx val="2"/>
          <c:order val="2"/>
          <c:tx>
            <c:strRef>
              <c:f>curve!$D$2</c:f>
              <c:strCache>
                <c:ptCount val="1"/>
                <c:pt idx="0">
                  <c:v>10%</c:v>
                </c:pt>
              </c:strCache>
            </c:strRef>
          </c:tx>
          <c:spPr>
            <a:ln w="9525" cap="rnd">
              <a:solidFill>
                <a:srgbClr val="FF66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FF66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D$3:$D$11</c:f>
              <c:numCache>
                <c:formatCode>0.000</c:formatCode>
                <c:ptCount val="9"/>
                <c:pt idx="0">
                  <c:v>0.25475265475449599</c:v>
                </c:pt>
                <c:pt idx="1">
                  <c:v>0.24342433349353301</c:v>
                </c:pt>
                <c:pt idx="2">
                  <c:v>0.24461877348498101</c:v>
                </c:pt>
                <c:pt idx="3">
                  <c:v>0.23823712933911501</c:v>
                </c:pt>
                <c:pt idx="4">
                  <c:v>0.23508685951156799</c:v>
                </c:pt>
                <c:pt idx="5">
                  <c:v>0.226692196475481</c:v>
                </c:pt>
                <c:pt idx="6">
                  <c:v>0.22024619098195899</c:v>
                </c:pt>
                <c:pt idx="7">
                  <c:v>0.212794998320779</c:v>
                </c:pt>
                <c:pt idx="8">
                  <c:v>0.2061585725430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344-4BDF-9849-72ECE1269FD4}"/>
            </c:ext>
          </c:extLst>
        </c:ser>
        <c:ser>
          <c:idx val="3"/>
          <c:order val="3"/>
          <c:tx>
            <c:strRef>
              <c:f>curve!$E$2</c:f>
              <c:strCache>
                <c:ptCount val="1"/>
                <c:pt idx="0">
                  <c:v>15%</c:v>
                </c:pt>
              </c:strCache>
            </c:strRef>
          </c:tx>
          <c:spPr>
            <a:ln w="952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E$3:$E$11</c:f>
              <c:numCache>
                <c:formatCode>0.000</c:formatCode>
                <c:ptCount val="9"/>
                <c:pt idx="0">
                  <c:v>0.21193666713144799</c:v>
                </c:pt>
                <c:pt idx="1">
                  <c:v>0.20233547247664099</c:v>
                </c:pt>
                <c:pt idx="2">
                  <c:v>0.20367450806585599</c:v>
                </c:pt>
                <c:pt idx="3">
                  <c:v>0.19783747908152199</c:v>
                </c:pt>
                <c:pt idx="4">
                  <c:v>0.19474883004626201</c:v>
                </c:pt>
                <c:pt idx="5">
                  <c:v>0.18704286680253199</c:v>
                </c:pt>
                <c:pt idx="6">
                  <c:v>0.181415638503647</c:v>
                </c:pt>
                <c:pt idx="7">
                  <c:v>0.17512411375550599</c:v>
                </c:pt>
                <c:pt idx="8">
                  <c:v>0.16966657563372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344-4BDF-9849-72ECE1269F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0315856"/>
        <c:axId val="1050317904"/>
      </c:lineChart>
      <c:catAx>
        <c:axId val="1050315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7904"/>
        <c:crosses val="autoZero"/>
        <c:auto val="1"/>
        <c:lblAlgn val="ctr"/>
        <c:lblOffset val="100"/>
        <c:noMultiLvlLbl val="0"/>
      </c:catAx>
      <c:valAx>
        <c:axId val="1050317904"/>
        <c:scaling>
          <c:orientation val="minMax"/>
          <c:max val="0.8"/>
          <c:min val="0.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5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5263650867171009"/>
          <c:y val="8.0701754385964913E-3"/>
          <c:w val="0.60649940816221504"/>
          <c:h val="0.17830363309849426"/>
        </c:manualLayout>
      </c:layout>
      <c:overlay val="0"/>
      <c:spPr>
        <a:solidFill>
          <a:schemeClr val="bg1"/>
        </a:solidFill>
        <a:ln w="6350">
          <a:solidFill>
            <a:schemeClr val="tx1">
              <a:lumMod val="50000"/>
              <a:lumOff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946850393700803E-2"/>
          <c:y val="2.0682779235928799E-2"/>
          <c:w val="0.92605314960629903"/>
          <c:h val="0.95863444152814303"/>
        </c:manualLayout>
      </c:layout>
      <c:lineChart>
        <c:grouping val="standard"/>
        <c:varyColors val="0"/>
        <c:ser>
          <c:idx val="0"/>
          <c:order val="0"/>
          <c:tx>
            <c:strRef>
              <c:f>curve!$B$15</c:f>
              <c:strCache>
                <c:ptCount val="1"/>
                <c:pt idx="0">
                  <c:v>1%</c:v>
                </c:pt>
              </c:strCache>
            </c:strRef>
          </c:tx>
          <c:spPr>
            <a:ln w="95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B$16:$B$24</c:f>
              <c:numCache>
                <c:formatCode>0.000</c:formatCode>
                <c:ptCount val="9"/>
                <c:pt idx="0">
                  <c:v>0.30691657926960603</c:v>
                </c:pt>
                <c:pt idx="1">
                  <c:v>0.28965279999971999</c:v>
                </c:pt>
                <c:pt idx="2">
                  <c:v>0.28760872437310903</c:v>
                </c:pt>
                <c:pt idx="3">
                  <c:v>0.27877684612895498</c:v>
                </c:pt>
                <c:pt idx="4">
                  <c:v>0.26580356024879997</c:v>
                </c:pt>
                <c:pt idx="5">
                  <c:v>0.25111295255114902</c:v>
                </c:pt>
                <c:pt idx="6">
                  <c:v>0.24329856557302099</c:v>
                </c:pt>
                <c:pt idx="7">
                  <c:v>0.236628539762509</c:v>
                </c:pt>
                <c:pt idx="8">
                  <c:v>0.23111418371540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CC8-4C21-AB4F-0C80D0D0DE5B}"/>
            </c:ext>
          </c:extLst>
        </c:ser>
        <c:ser>
          <c:idx val="1"/>
          <c:order val="1"/>
          <c:tx>
            <c:strRef>
              <c:f>curve!$C$15</c:f>
              <c:strCache>
                <c:ptCount val="1"/>
                <c:pt idx="0">
                  <c:v>5%</c:v>
                </c:pt>
              </c:strCache>
            </c:strRef>
          </c:tx>
          <c:spPr>
            <a:ln w="952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C$16:$C$24</c:f>
              <c:numCache>
                <c:formatCode>0.000</c:formatCode>
                <c:ptCount val="9"/>
                <c:pt idx="0">
                  <c:v>0.181362711236983</c:v>
                </c:pt>
                <c:pt idx="1">
                  <c:v>0.17191260609015499</c:v>
                </c:pt>
                <c:pt idx="2">
                  <c:v>0.17006345673911299</c:v>
                </c:pt>
                <c:pt idx="3">
                  <c:v>0.16427560746918499</c:v>
                </c:pt>
                <c:pt idx="4">
                  <c:v>0.15523807751785701</c:v>
                </c:pt>
                <c:pt idx="5">
                  <c:v>0.14635304731936899</c:v>
                </c:pt>
                <c:pt idx="6">
                  <c:v>0.14224227030405001</c:v>
                </c:pt>
                <c:pt idx="7">
                  <c:v>0.138730702390717</c:v>
                </c:pt>
                <c:pt idx="8">
                  <c:v>0.13603305295361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CC8-4C21-AB4F-0C80D0D0DE5B}"/>
            </c:ext>
          </c:extLst>
        </c:ser>
        <c:ser>
          <c:idx val="2"/>
          <c:order val="2"/>
          <c:tx>
            <c:strRef>
              <c:f>curve!$D$15</c:f>
              <c:strCache>
                <c:ptCount val="1"/>
                <c:pt idx="0">
                  <c:v>10%</c:v>
                </c:pt>
              </c:strCache>
            </c:strRef>
          </c:tx>
          <c:spPr>
            <a:ln w="9525" cap="rnd">
              <a:solidFill>
                <a:srgbClr val="ED7D3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FF66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D$16:$D$24</c:f>
              <c:numCache>
                <c:formatCode>0.000</c:formatCode>
                <c:ptCount val="9"/>
                <c:pt idx="0">
                  <c:v>0.14330786226405501</c:v>
                </c:pt>
                <c:pt idx="1">
                  <c:v>0.13554813038265301</c:v>
                </c:pt>
                <c:pt idx="2">
                  <c:v>0.133867063861795</c:v>
                </c:pt>
                <c:pt idx="3">
                  <c:v>0.1289519117432</c:v>
                </c:pt>
                <c:pt idx="4">
                  <c:v>0.121386581331189</c:v>
                </c:pt>
                <c:pt idx="5">
                  <c:v>0.114339646420328</c:v>
                </c:pt>
                <c:pt idx="6">
                  <c:v>0.111204499188473</c:v>
                </c:pt>
                <c:pt idx="7">
                  <c:v>0.108538077695653</c:v>
                </c:pt>
                <c:pt idx="8">
                  <c:v>0.106548796038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CC8-4C21-AB4F-0C80D0D0DE5B}"/>
            </c:ext>
          </c:extLst>
        </c:ser>
        <c:ser>
          <c:idx val="3"/>
          <c:order val="3"/>
          <c:tx>
            <c:strRef>
              <c:f>curve!$E$15</c:f>
              <c:strCache>
                <c:ptCount val="1"/>
                <c:pt idx="0">
                  <c:v>15%</c:v>
                </c:pt>
              </c:strCache>
            </c:strRef>
          </c:tx>
          <c:spPr>
            <a:ln w="952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curve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curve!$E$16:$E$24</c:f>
              <c:numCache>
                <c:formatCode>0.000</c:formatCode>
                <c:ptCount val="9"/>
                <c:pt idx="0">
                  <c:v>0.12100712194202801</c:v>
                </c:pt>
                <c:pt idx="1">
                  <c:v>0.114288101835059</c:v>
                </c:pt>
                <c:pt idx="2">
                  <c:v>0.112699326714657</c:v>
                </c:pt>
                <c:pt idx="3">
                  <c:v>0.108279804137279</c:v>
                </c:pt>
                <c:pt idx="4">
                  <c:v>0.101577951297362</c:v>
                </c:pt>
                <c:pt idx="5">
                  <c:v>9.5562175743233793E-2</c:v>
                </c:pt>
                <c:pt idx="6">
                  <c:v>9.2956965913473799E-2</c:v>
                </c:pt>
                <c:pt idx="7">
                  <c:v>9.0753560695918098E-2</c:v>
                </c:pt>
                <c:pt idx="8">
                  <c:v>8.913857406605299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CC8-4C21-AB4F-0C80D0D0DE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0315856"/>
        <c:axId val="1050317904"/>
      </c:lineChart>
      <c:catAx>
        <c:axId val="1050315856"/>
        <c:scaling>
          <c:orientation val="minMax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7904"/>
        <c:crosses val="autoZero"/>
        <c:auto val="1"/>
        <c:lblAlgn val="ctr"/>
        <c:lblOffset val="100"/>
        <c:noMultiLvlLbl val="0"/>
      </c:catAx>
      <c:valAx>
        <c:axId val="1050317904"/>
        <c:scaling>
          <c:orientation val="minMax"/>
          <c:max val="0.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585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4579109650128681"/>
          <c:y val="1.6842105263157894E-2"/>
          <c:w val="0.60718956246973987"/>
          <c:h val="0.15198784362480999"/>
        </c:manualLayout>
      </c:layout>
      <c:overlay val="0"/>
      <c:spPr>
        <a:solidFill>
          <a:schemeClr val="bg1"/>
        </a:solidFill>
        <a:ln w="6350">
          <a:solidFill>
            <a:schemeClr val="tx1">
              <a:lumMod val="50000"/>
              <a:lumOff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38864860202334"/>
          <c:y val="2.0682779235928799E-2"/>
          <c:w val="0.81456113760427828"/>
          <c:h val="0.71305717220130094"/>
        </c:manualLayout>
      </c:layout>
      <c:lineChart>
        <c:grouping val="standard"/>
        <c:varyColors val="0"/>
        <c:ser>
          <c:idx val="0"/>
          <c:order val="0"/>
          <c:tx>
            <c:strRef>
              <c:f>'curve (Ontology)'!$B$2</c:f>
              <c:strCache>
                <c:ptCount val="1"/>
                <c:pt idx="0">
                  <c:v>1%</c:v>
                </c:pt>
              </c:strCache>
            </c:strRef>
          </c:tx>
          <c:spPr>
            <a:ln w="95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B$3:$B$11</c:f>
              <c:numCache>
                <c:formatCode>0.000</c:formatCode>
                <c:ptCount val="9"/>
                <c:pt idx="0">
                  <c:v>0.14463850180766499</c:v>
                </c:pt>
                <c:pt idx="1">
                  <c:v>0.14630511946276101</c:v>
                </c:pt>
                <c:pt idx="2">
                  <c:v>0.14606937477880999</c:v>
                </c:pt>
                <c:pt idx="3">
                  <c:v>0.146849293591614</c:v>
                </c:pt>
                <c:pt idx="4">
                  <c:v>0.146628282807482</c:v>
                </c:pt>
                <c:pt idx="5">
                  <c:v>0.146653938551003</c:v>
                </c:pt>
                <c:pt idx="6">
                  <c:v>0.146365319837509</c:v>
                </c:pt>
                <c:pt idx="7">
                  <c:v>0.14637891248520199</c:v>
                </c:pt>
                <c:pt idx="8">
                  <c:v>0.1466305729874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509-49E4-9B81-95D89F45F83A}"/>
            </c:ext>
          </c:extLst>
        </c:ser>
        <c:ser>
          <c:idx val="1"/>
          <c:order val="1"/>
          <c:tx>
            <c:strRef>
              <c:f>'curve (Ontology)'!$C$2</c:f>
              <c:strCache>
                <c:ptCount val="1"/>
                <c:pt idx="0">
                  <c:v>5%</c:v>
                </c:pt>
              </c:strCache>
            </c:strRef>
          </c:tx>
          <c:spPr>
            <a:ln w="952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C$3:$C$11</c:f>
              <c:numCache>
                <c:formatCode>0.000</c:formatCode>
                <c:ptCount val="9"/>
                <c:pt idx="0">
                  <c:v>8.6280592304321405E-2</c:v>
                </c:pt>
                <c:pt idx="1">
                  <c:v>8.5378241013939496E-2</c:v>
                </c:pt>
                <c:pt idx="2">
                  <c:v>8.5650181747364801E-2</c:v>
                </c:pt>
                <c:pt idx="3">
                  <c:v>8.6029490389375005E-2</c:v>
                </c:pt>
                <c:pt idx="4">
                  <c:v>8.5828311515545402E-2</c:v>
                </c:pt>
                <c:pt idx="5">
                  <c:v>8.5830544828444696E-2</c:v>
                </c:pt>
                <c:pt idx="6">
                  <c:v>8.5699212817481898E-2</c:v>
                </c:pt>
                <c:pt idx="7">
                  <c:v>8.5670683442040194E-2</c:v>
                </c:pt>
                <c:pt idx="8">
                  <c:v>8.57576223863582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509-49E4-9B81-95D89F45F83A}"/>
            </c:ext>
          </c:extLst>
        </c:ser>
        <c:ser>
          <c:idx val="2"/>
          <c:order val="2"/>
          <c:tx>
            <c:strRef>
              <c:f>'curve (Ontology)'!$D$2</c:f>
              <c:strCache>
                <c:ptCount val="1"/>
                <c:pt idx="0">
                  <c:v>10%</c:v>
                </c:pt>
              </c:strCache>
            </c:strRef>
          </c:tx>
          <c:spPr>
            <a:ln w="9525" cap="rnd">
              <a:solidFill>
                <a:srgbClr val="FF66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FF66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D$3:$D$11</c:f>
              <c:numCache>
                <c:formatCode>0.000</c:formatCode>
                <c:ptCount val="9"/>
                <c:pt idx="0">
                  <c:v>6.8573024121252296E-2</c:v>
                </c:pt>
                <c:pt idx="1">
                  <c:v>6.7741697058894906E-2</c:v>
                </c:pt>
                <c:pt idx="2">
                  <c:v>6.7996359574105103E-2</c:v>
                </c:pt>
                <c:pt idx="3">
                  <c:v>6.8272577437351198E-2</c:v>
                </c:pt>
                <c:pt idx="4">
                  <c:v>6.8104479985593699E-2</c:v>
                </c:pt>
                <c:pt idx="5">
                  <c:v>6.8111112578896904E-2</c:v>
                </c:pt>
                <c:pt idx="6">
                  <c:v>6.8012721079034694E-2</c:v>
                </c:pt>
                <c:pt idx="7">
                  <c:v>6.7985610882005706E-2</c:v>
                </c:pt>
                <c:pt idx="8">
                  <c:v>6.805143745226409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509-49E4-9B81-95D89F45F83A}"/>
            </c:ext>
          </c:extLst>
        </c:ser>
        <c:ser>
          <c:idx val="3"/>
          <c:order val="3"/>
          <c:tx>
            <c:strRef>
              <c:f>'curve (Ontology)'!$E$2</c:f>
              <c:strCache>
                <c:ptCount val="1"/>
                <c:pt idx="0">
                  <c:v>15%</c:v>
                </c:pt>
              </c:strCache>
            </c:strRef>
          </c:tx>
          <c:spPr>
            <a:ln w="952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3:$A$11</c:f>
              <c:numCache>
                <c:formatCode>General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E$3:$E$11</c:f>
              <c:numCache>
                <c:formatCode>0.000</c:formatCode>
                <c:ptCount val="9"/>
                <c:pt idx="0">
                  <c:v>5.7833151261594398E-2</c:v>
                </c:pt>
                <c:pt idx="1">
                  <c:v>5.7118202813483898E-2</c:v>
                </c:pt>
                <c:pt idx="2">
                  <c:v>5.73406469554186E-2</c:v>
                </c:pt>
                <c:pt idx="3">
                  <c:v>5.7565208438924598E-2</c:v>
                </c:pt>
                <c:pt idx="4">
                  <c:v>5.7420399806884001E-2</c:v>
                </c:pt>
                <c:pt idx="5">
                  <c:v>5.7428304988759997E-2</c:v>
                </c:pt>
                <c:pt idx="6">
                  <c:v>5.7350289066993798E-2</c:v>
                </c:pt>
                <c:pt idx="7">
                  <c:v>5.7325561477311701E-2</c:v>
                </c:pt>
                <c:pt idx="8">
                  <c:v>5.73794189575531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509-49E4-9B81-95D89F45F8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0315856"/>
        <c:axId val="1050317904"/>
      </c:lineChart>
      <c:catAx>
        <c:axId val="1050315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7904"/>
        <c:crosses val="autoZero"/>
        <c:auto val="1"/>
        <c:lblAlgn val="ctr"/>
        <c:lblOffset val="100"/>
        <c:noMultiLvlLbl val="0"/>
      </c:catAx>
      <c:valAx>
        <c:axId val="1050317904"/>
        <c:scaling>
          <c:orientation val="minMax"/>
          <c:max val="0.24000000000000002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0_);[Red]\(#,##0.00\)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5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927885227938739"/>
          <c:y val="4.5827532428011714E-2"/>
          <c:w val="0.67959138910453099"/>
          <c:h val="0.18898246414850317"/>
        </c:manualLayout>
      </c:layout>
      <c:overlay val="0"/>
      <c:spPr>
        <a:solidFill>
          <a:schemeClr val="bg1"/>
        </a:solidFill>
        <a:ln w="6350">
          <a:solidFill>
            <a:schemeClr val="tx1">
              <a:lumMod val="50000"/>
              <a:lumOff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3946850393700803E-2"/>
          <c:y val="2.0682779235928799E-2"/>
          <c:w val="0.92605314960629903"/>
          <c:h val="0.95863444152814303"/>
        </c:manualLayout>
      </c:layout>
      <c:lineChart>
        <c:grouping val="standard"/>
        <c:varyColors val="0"/>
        <c:ser>
          <c:idx val="0"/>
          <c:order val="0"/>
          <c:tx>
            <c:strRef>
              <c:f>'curve (Ontology)'!$B$15</c:f>
              <c:strCache>
                <c:ptCount val="1"/>
                <c:pt idx="0">
                  <c:v>1%</c:v>
                </c:pt>
              </c:strCache>
            </c:strRef>
          </c:tx>
          <c:spPr>
            <a:ln w="95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C0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G$3:$G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B$16:$B$24</c:f>
              <c:numCache>
                <c:formatCode>0.000</c:formatCode>
                <c:ptCount val="9"/>
                <c:pt idx="0">
                  <c:v>0.20555102251190099</c:v>
                </c:pt>
                <c:pt idx="1">
                  <c:v>0.202185410140195</c:v>
                </c:pt>
                <c:pt idx="2">
                  <c:v>0.20487353698857</c:v>
                </c:pt>
                <c:pt idx="3">
                  <c:v>0.20298043305364399</c:v>
                </c:pt>
                <c:pt idx="4">
                  <c:v>0.20277455202550501</c:v>
                </c:pt>
                <c:pt idx="5">
                  <c:v>0.20308132430025899</c:v>
                </c:pt>
                <c:pt idx="6">
                  <c:v>0.203343689968388</c:v>
                </c:pt>
                <c:pt idx="7">
                  <c:v>0.203374228370615</c:v>
                </c:pt>
                <c:pt idx="8">
                  <c:v>0.20341720868947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3F6-442D-A78F-152053D62978}"/>
            </c:ext>
          </c:extLst>
        </c:ser>
        <c:ser>
          <c:idx val="1"/>
          <c:order val="1"/>
          <c:tx>
            <c:strRef>
              <c:f>'curve (Ontology)'!$C$15</c:f>
              <c:strCache>
                <c:ptCount val="1"/>
                <c:pt idx="0">
                  <c:v>5%</c:v>
                </c:pt>
              </c:strCache>
            </c:strRef>
          </c:tx>
          <c:spPr>
            <a:ln w="952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H$3:$H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C$16:$C$24</c:f>
              <c:numCache>
                <c:formatCode>0.000</c:formatCode>
                <c:ptCount val="9"/>
                <c:pt idx="0">
                  <c:v>0.116713255166195</c:v>
                </c:pt>
                <c:pt idx="1">
                  <c:v>0.11538725832364601</c:v>
                </c:pt>
                <c:pt idx="2">
                  <c:v>0.11644133333598</c:v>
                </c:pt>
                <c:pt idx="3">
                  <c:v>0.115726265625489</c:v>
                </c:pt>
                <c:pt idx="4">
                  <c:v>0.11563315576698199</c:v>
                </c:pt>
                <c:pt idx="5">
                  <c:v>0.11577234865894299</c:v>
                </c:pt>
                <c:pt idx="6">
                  <c:v>0.115935404167373</c:v>
                </c:pt>
                <c:pt idx="7">
                  <c:v>0.115973432943689</c:v>
                </c:pt>
                <c:pt idx="8">
                  <c:v>0.1159646711733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3F6-442D-A78F-152053D62978}"/>
            </c:ext>
          </c:extLst>
        </c:ser>
        <c:ser>
          <c:idx val="2"/>
          <c:order val="2"/>
          <c:tx>
            <c:strRef>
              <c:f>'curve (Ontology)'!$D$15</c:f>
              <c:strCache>
                <c:ptCount val="1"/>
                <c:pt idx="0">
                  <c:v>10%</c:v>
                </c:pt>
              </c:strCache>
            </c:strRef>
          </c:tx>
          <c:spPr>
            <a:ln w="9525" cap="rnd">
              <a:solidFill>
                <a:srgbClr val="ED7D3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FF66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I$3:$I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D$16:$D$24</c:f>
              <c:numCache>
                <c:formatCode>0.000</c:formatCode>
                <c:ptCount val="9"/>
                <c:pt idx="0">
                  <c:v>9.1017389221613204E-2</c:v>
                </c:pt>
                <c:pt idx="1">
                  <c:v>8.9906394321857E-2</c:v>
                </c:pt>
                <c:pt idx="2">
                  <c:v>9.0794658636296793E-2</c:v>
                </c:pt>
                <c:pt idx="3">
                  <c:v>9.0218623117416297E-2</c:v>
                </c:pt>
                <c:pt idx="4">
                  <c:v>9.0150308975962407E-2</c:v>
                </c:pt>
                <c:pt idx="5">
                  <c:v>9.0243242346582597E-2</c:v>
                </c:pt>
                <c:pt idx="6">
                  <c:v>9.0384671353116494E-2</c:v>
                </c:pt>
                <c:pt idx="7">
                  <c:v>9.0406533682451995E-2</c:v>
                </c:pt>
                <c:pt idx="8">
                  <c:v>9.039601105233850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3F6-442D-A78F-152053D62978}"/>
            </c:ext>
          </c:extLst>
        </c:ser>
        <c:ser>
          <c:idx val="3"/>
          <c:order val="3"/>
          <c:tx>
            <c:strRef>
              <c:f>'curve (Ontology)'!$E$15</c:f>
              <c:strCache>
                <c:ptCount val="1"/>
                <c:pt idx="0">
                  <c:v>15%</c:v>
                </c:pt>
              </c:strCache>
            </c:strRef>
          </c:tx>
          <c:spPr>
            <a:ln w="952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'[1]GO curve'!$J$3:$J$11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  <a:round/>
              </a:ln>
              <a:effectLst/>
            </c:spPr>
          </c:errBars>
          <c:cat>
            <c:numRef>
              <c:f>'curve (Ontology)'!$A$16:$A$24</c:f>
              <c:numCache>
                <c:formatCode>0</c:formatCode>
                <c:ptCount val="9"/>
                <c:pt idx="0">
                  <c:v>10</c:v>
                </c:pt>
                <c:pt idx="1">
                  <c:v>20</c:v>
                </c:pt>
                <c:pt idx="2">
                  <c:v>30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500</c:v>
                </c:pt>
                <c:pt idx="8">
                  <c:v>1000</c:v>
                </c:pt>
              </c:numCache>
            </c:numRef>
          </c:cat>
          <c:val>
            <c:numRef>
              <c:f>'curve (Ontology)'!$E$16:$E$24</c:f>
              <c:numCache>
                <c:formatCode>0.000</c:formatCode>
                <c:ptCount val="9"/>
                <c:pt idx="0">
                  <c:v>7.6147446935301996E-2</c:v>
                </c:pt>
                <c:pt idx="1">
                  <c:v>7.5207245467238004E-2</c:v>
                </c:pt>
                <c:pt idx="2">
                  <c:v>7.5963406747421705E-2</c:v>
                </c:pt>
                <c:pt idx="3">
                  <c:v>7.5484488438777295E-2</c:v>
                </c:pt>
                <c:pt idx="4">
                  <c:v>7.54277080069541E-2</c:v>
                </c:pt>
                <c:pt idx="5">
                  <c:v>7.5497375500947594E-2</c:v>
                </c:pt>
                <c:pt idx="6">
                  <c:v>7.5619945239847094E-2</c:v>
                </c:pt>
                <c:pt idx="7">
                  <c:v>7.5635015587365198E-2</c:v>
                </c:pt>
                <c:pt idx="8">
                  <c:v>7.562522118273079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3F6-442D-A78F-152053D629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0315856"/>
        <c:axId val="1050317904"/>
      </c:lineChart>
      <c:catAx>
        <c:axId val="1050315856"/>
        <c:scaling>
          <c:orientation val="minMax"/>
        </c:scaling>
        <c:delete val="0"/>
        <c:axPos val="b"/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7904"/>
        <c:crosses val="autoZero"/>
        <c:auto val="1"/>
        <c:lblAlgn val="ctr"/>
        <c:lblOffset val="100"/>
        <c:noMultiLvlLbl val="0"/>
      </c:catAx>
      <c:valAx>
        <c:axId val="1050317904"/>
        <c:scaling>
          <c:orientation val="minMax"/>
          <c:max val="0.3000000000000000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0_);[Red]\(#,##0.00\)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50315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6490896352805252"/>
          <c:y val="6.0701754385964909E-2"/>
          <c:w val="0.58196252837207774"/>
          <c:h val="0.15198784362480999"/>
        </c:manualLayout>
      </c:layout>
      <c:overlay val="0"/>
      <c:spPr>
        <a:solidFill>
          <a:schemeClr val="bg1"/>
        </a:solidFill>
        <a:ln w="6350">
          <a:solidFill>
            <a:schemeClr val="tx1">
              <a:lumMod val="50000"/>
              <a:lumOff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C48623-5795-4CED-9C3C-EEB9BA6F5269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D08EF5-7F8E-4A04-99A5-9022DC8C42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44492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08EF5-7F8E-4A04-99A5-9022DC8C4279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30189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8FD601-5B5B-2490-9F47-5F0EB7E561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9EC4EE3A-60DC-2F00-8E1D-1E317DB9EA0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75CE966B-1773-8CC9-3873-2A405A81146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738DD05-B7E1-49C5-E2BC-EDEBA429E83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08EF5-7F8E-4A04-99A5-9022DC8C4279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231942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389CF5-0F2F-A6FE-A5D6-BA62C37362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>
            <a:extLst>
              <a:ext uri="{FF2B5EF4-FFF2-40B4-BE49-F238E27FC236}">
                <a16:creationId xmlns:a16="http://schemas.microsoft.com/office/drawing/2014/main" id="{2AE06C10-1580-4297-9868-730179AA55F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>
            <a:extLst>
              <a:ext uri="{FF2B5EF4-FFF2-40B4-BE49-F238E27FC236}">
                <a16:creationId xmlns:a16="http://schemas.microsoft.com/office/drawing/2014/main" id="{2D88C5BB-73CD-48AA-0980-FCF6341B302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6DCDD0C-D3ED-075C-C036-91A397549DF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08EF5-7F8E-4A04-99A5-9022DC8C4279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9361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659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2100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00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4106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7353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8902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5255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9133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9246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928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488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CC6810-9EDB-45A9-8B92-0BB1EA11B631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3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image" Target="../media/image2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13B2FF-6265-E05F-CE14-6A996B23C9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제목 2">
            <a:extLst>
              <a:ext uri="{FF2B5EF4-FFF2-40B4-BE49-F238E27FC236}">
                <a16:creationId xmlns:a16="http://schemas.microsoft.com/office/drawing/2014/main" id="{F4304A01-5798-26C5-BB0F-052D8786AF18}"/>
              </a:ext>
            </a:extLst>
          </p:cNvPr>
          <p:cNvSpPr txBox="1">
            <a:spLocks/>
          </p:cNvSpPr>
          <p:nvPr/>
        </p:nvSpPr>
        <p:spPr>
          <a:xfrm>
            <a:off x="525824" y="4415343"/>
            <a:ext cx="5806352" cy="1609078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ko-KR" sz="1050" dirty="0"/>
              <a:t>Supplementary Figure 1. Distribution of weighted Tanimoto scores</a:t>
            </a:r>
            <a:r>
              <a:rPr lang="ko-KR" altLang="en-US" sz="1050" dirty="0"/>
              <a:t> </a:t>
            </a:r>
            <a:r>
              <a:rPr lang="en-US" altLang="ko-KR" sz="1050" dirty="0"/>
              <a:t>(</a:t>
            </a:r>
            <a:r>
              <a:rPr lang="en-US" altLang="ko-KR" sz="1050" i="1" dirty="0"/>
              <a:t>Tw</a:t>
            </a:r>
            <a:r>
              <a:rPr lang="en-US" altLang="ko-KR" sz="1050" dirty="0"/>
              <a:t>) in gene networks</a:t>
            </a:r>
            <a:r>
              <a:rPr lang="en-US" altLang="ko-KR" sz="1050" b="0" dirty="0"/>
              <a:t>. Gene networks were constructed using randomly selected gene lists of varying sizes. For each gene group ranging from 10 to 1,000 genes, a total of 10,000 networks were generated. </a:t>
            </a:r>
            <a:r>
              <a:rPr lang="en-US" altLang="ko-KR" sz="1050" b="0" dirty="0">
                <a:solidFill>
                  <a:srgbClr val="FF0000"/>
                </a:solidFill>
              </a:rPr>
              <a:t>(A, C) Probability density distributions of Tw scores based on </a:t>
            </a:r>
            <a:r>
              <a:rPr lang="en-US" altLang="ko-KR" sz="1050" b="0" dirty="0" err="1">
                <a:solidFill>
                  <a:srgbClr val="FF0000"/>
                </a:solidFill>
              </a:rPr>
              <a:t>GOBP</a:t>
            </a:r>
            <a:r>
              <a:rPr lang="en-US" altLang="ko-KR" sz="1050" b="0" dirty="0">
                <a:solidFill>
                  <a:srgbClr val="FF0000"/>
                </a:solidFill>
              </a:rPr>
              <a:t> and </a:t>
            </a:r>
            <a:r>
              <a:rPr lang="en-US" altLang="ko-KR" sz="1050" b="0" dirty="0" err="1">
                <a:solidFill>
                  <a:srgbClr val="FF0000"/>
                </a:solidFill>
              </a:rPr>
              <a:t>HPO</a:t>
            </a:r>
            <a:r>
              <a:rPr lang="en-US" altLang="ko-KR" sz="1050" b="0" dirty="0">
                <a:solidFill>
                  <a:srgbClr val="FF0000"/>
                </a:solidFill>
              </a:rPr>
              <a:t>, respectively. (B, D) Top 1–15% Tw cutoff values across different gene list sizes for </a:t>
            </a:r>
            <a:r>
              <a:rPr lang="en-US" altLang="ko-KR" sz="1050" b="0" dirty="0" err="1">
                <a:solidFill>
                  <a:srgbClr val="FF0000"/>
                </a:solidFill>
              </a:rPr>
              <a:t>GOBP</a:t>
            </a:r>
            <a:r>
              <a:rPr lang="en-US" altLang="ko-KR" sz="1050" b="0" dirty="0">
                <a:solidFill>
                  <a:srgbClr val="FF0000"/>
                </a:solidFill>
              </a:rPr>
              <a:t>- and </a:t>
            </a:r>
            <a:r>
              <a:rPr lang="en-US" altLang="ko-KR" sz="1050" b="0" dirty="0" err="1">
                <a:solidFill>
                  <a:srgbClr val="FF0000"/>
                </a:solidFill>
              </a:rPr>
              <a:t>HPO</a:t>
            </a:r>
            <a:r>
              <a:rPr lang="en-US" altLang="ko-KR" sz="1050" b="0" dirty="0">
                <a:solidFill>
                  <a:srgbClr val="FF0000"/>
                </a:solidFill>
              </a:rPr>
              <a:t>-based networks, respectively. These simulations were used to quantify the expected distribution of Tw values across gene-list sizes and to determine list-size–dependent Tw cutoffs. The figure summarizes the range of Tw values and the corresponding upper quantile thresholds used for network construction.</a:t>
            </a: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A292FA23-2745-43FC-AA81-015DDE3CEC1D}"/>
              </a:ext>
            </a:extLst>
          </p:cNvPr>
          <p:cNvGrpSpPr/>
          <p:nvPr/>
        </p:nvGrpSpPr>
        <p:grpSpPr>
          <a:xfrm>
            <a:off x="895176" y="707664"/>
            <a:ext cx="4801243" cy="3533449"/>
            <a:chOff x="895176" y="707664"/>
            <a:chExt cx="4801243" cy="3533449"/>
          </a:xfrm>
        </p:grpSpPr>
        <p:sp>
          <p:nvSpPr>
            <p:cNvPr id="36" name="제목 2">
              <a:extLst>
                <a:ext uri="{FF2B5EF4-FFF2-40B4-BE49-F238E27FC236}">
                  <a16:creationId xmlns:a16="http://schemas.microsoft.com/office/drawing/2014/main" id="{291D07F7-124E-A5F9-77A2-A75CFDF7A1BE}"/>
                </a:ext>
              </a:extLst>
            </p:cNvPr>
            <p:cNvSpPr txBox="1">
              <a:spLocks/>
            </p:cNvSpPr>
            <p:nvPr/>
          </p:nvSpPr>
          <p:spPr>
            <a:xfrm>
              <a:off x="3345131" y="2435280"/>
              <a:ext cx="167735" cy="138628"/>
            </a:xfrm>
            <a:prstGeom prst="rect">
              <a:avLst/>
            </a:prstGeom>
          </p:spPr>
          <p:txBody>
            <a:bodyPr vert="horz" wrap="square" lIns="0" tIns="0" rIns="0" bIns="0" rtlCol="0" anchor="t">
              <a:sp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1001" b="0" dirty="0"/>
                <a:t>(D)</a:t>
              </a:r>
            </a:p>
          </p:txBody>
        </p:sp>
        <p:sp>
          <p:nvSpPr>
            <p:cNvPr id="37" name="제목 2">
              <a:extLst>
                <a:ext uri="{FF2B5EF4-FFF2-40B4-BE49-F238E27FC236}">
                  <a16:creationId xmlns:a16="http://schemas.microsoft.com/office/drawing/2014/main" id="{F0F24C89-9C5A-A7B7-B24F-DA991BDF5534}"/>
                </a:ext>
              </a:extLst>
            </p:cNvPr>
            <p:cNvSpPr txBox="1">
              <a:spLocks/>
            </p:cNvSpPr>
            <p:nvPr/>
          </p:nvSpPr>
          <p:spPr>
            <a:xfrm>
              <a:off x="3345132" y="707664"/>
              <a:ext cx="167735" cy="138628"/>
            </a:xfrm>
            <a:prstGeom prst="rect">
              <a:avLst/>
            </a:prstGeom>
          </p:spPr>
          <p:txBody>
            <a:bodyPr vert="horz" wrap="square" lIns="0" tIns="0" rIns="0" bIns="0" rtlCol="0" anchor="t">
              <a:sp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1001" b="0" dirty="0"/>
                <a:t>(B)</a:t>
              </a:r>
            </a:p>
          </p:txBody>
        </p:sp>
        <p:sp>
          <p:nvSpPr>
            <p:cNvPr id="2" name="제목 2">
              <a:extLst>
                <a:ext uri="{FF2B5EF4-FFF2-40B4-BE49-F238E27FC236}">
                  <a16:creationId xmlns:a16="http://schemas.microsoft.com/office/drawing/2014/main" id="{12C918DE-B381-F775-6250-B0A3B4BB80D9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160800" y="1393115"/>
              <a:ext cx="863863" cy="167735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</a:t>
              </a:r>
              <a:r>
                <a:rPr lang="en-US" altLang="ko-KR" sz="900" b="0" i="1" dirty="0"/>
                <a:t>T</a:t>
              </a:r>
              <a:r>
                <a:rPr lang="en-US" altLang="ko-KR" sz="1100" b="0" i="1" baseline="-25000" dirty="0"/>
                <a:t>w</a:t>
              </a:r>
              <a:r>
                <a:rPr lang="en-US" altLang="ko-KR" sz="900" b="0" i="1" baseline="-25000" dirty="0"/>
                <a:t>  </a:t>
              </a:r>
              <a:endParaRPr lang="en-US" altLang="ko-KR" sz="900" b="0" dirty="0"/>
            </a:p>
          </p:txBody>
        </p:sp>
        <p:sp>
          <p:nvSpPr>
            <p:cNvPr id="3" name="제목 2">
              <a:extLst>
                <a:ext uri="{FF2B5EF4-FFF2-40B4-BE49-F238E27FC236}">
                  <a16:creationId xmlns:a16="http://schemas.microsoft.com/office/drawing/2014/main" id="{5E54577C-77C3-3D5C-E34B-2E3FD7BE0584}"/>
                </a:ext>
              </a:extLst>
            </p:cNvPr>
            <p:cNvSpPr txBox="1">
              <a:spLocks/>
            </p:cNvSpPr>
            <p:nvPr/>
          </p:nvSpPr>
          <p:spPr>
            <a:xfrm>
              <a:off x="895176" y="2435280"/>
              <a:ext cx="167735" cy="138628"/>
            </a:xfrm>
            <a:prstGeom prst="rect">
              <a:avLst/>
            </a:prstGeom>
          </p:spPr>
          <p:txBody>
            <a:bodyPr vert="horz" wrap="square" lIns="0" tIns="0" rIns="0" bIns="0" rtlCol="0" anchor="t">
              <a:sp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1001" b="0" dirty="0"/>
                <a:t>(C)</a:t>
              </a:r>
            </a:p>
          </p:txBody>
        </p:sp>
        <p:sp>
          <p:nvSpPr>
            <p:cNvPr id="9" name="제목 2">
              <a:extLst>
                <a:ext uri="{FF2B5EF4-FFF2-40B4-BE49-F238E27FC236}">
                  <a16:creationId xmlns:a16="http://schemas.microsoft.com/office/drawing/2014/main" id="{E3E5CDF4-3A3D-AFDD-1B32-8FBA3E43CE68}"/>
                </a:ext>
              </a:extLst>
            </p:cNvPr>
            <p:cNvSpPr txBox="1">
              <a:spLocks/>
            </p:cNvSpPr>
            <p:nvPr/>
          </p:nvSpPr>
          <p:spPr>
            <a:xfrm>
              <a:off x="4009451" y="2249751"/>
              <a:ext cx="1647158" cy="214386"/>
            </a:xfrm>
            <a:prstGeom prst="rect">
              <a:avLst/>
            </a:prstGeom>
          </p:spPr>
          <p:txBody>
            <a:bodyPr vert="horz" lIns="91440" tIns="45721" rIns="91440" bIns="45721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900" b="0" dirty="0"/>
                <a:t># genes on GOBP networks</a:t>
              </a:r>
            </a:p>
          </p:txBody>
        </p:sp>
        <p:sp>
          <p:nvSpPr>
            <p:cNvPr id="10" name="제목 2">
              <a:extLst>
                <a:ext uri="{FF2B5EF4-FFF2-40B4-BE49-F238E27FC236}">
                  <a16:creationId xmlns:a16="http://schemas.microsoft.com/office/drawing/2014/main" id="{81C51D3D-190B-ABA9-20EC-FC9F20AA8CD2}"/>
                </a:ext>
              </a:extLst>
            </p:cNvPr>
            <p:cNvSpPr txBox="1">
              <a:spLocks/>
            </p:cNvSpPr>
            <p:nvPr/>
          </p:nvSpPr>
          <p:spPr>
            <a:xfrm>
              <a:off x="899363" y="707664"/>
              <a:ext cx="167735" cy="138628"/>
            </a:xfrm>
            <a:prstGeom prst="rect">
              <a:avLst/>
            </a:prstGeom>
          </p:spPr>
          <p:txBody>
            <a:bodyPr vert="horz" wrap="square" lIns="0" tIns="0" rIns="0" bIns="0" rtlCol="0" anchor="t">
              <a:sp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1001" b="0" dirty="0"/>
                <a:t>(A)</a:t>
              </a:r>
            </a:p>
          </p:txBody>
        </p:sp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EFEFF156-02ED-B511-D82A-3663C8D34A1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1738" y="846292"/>
              <a:ext cx="1781175" cy="1285875"/>
            </a:xfrm>
            <a:prstGeom prst="rect">
              <a:avLst/>
            </a:prstGeom>
          </p:spPr>
        </p:pic>
        <p:sp>
          <p:nvSpPr>
            <p:cNvPr id="4" name="제목 2">
              <a:extLst>
                <a:ext uri="{FF2B5EF4-FFF2-40B4-BE49-F238E27FC236}">
                  <a16:creationId xmlns:a16="http://schemas.microsoft.com/office/drawing/2014/main" id="{9D45AE8E-C449-E844-95EC-6220603CB042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671683" y="1391442"/>
              <a:ext cx="1004386" cy="157882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Probability</a:t>
              </a:r>
              <a:r>
                <a:rPr lang="ko-KR" altLang="en-US" sz="900" b="0" dirty="0"/>
                <a:t> </a:t>
              </a:r>
              <a:r>
                <a:rPr lang="en-US" altLang="ko-KR" sz="900" b="0" dirty="0"/>
                <a:t>density</a:t>
              </a:r>
              <a:r>
                <a:rPr lang="en-US" altLang="ko-KR" sz="900" b="0" baseline="-25000" dirty="0"/>
                <a:t>  </a:t>
              </a:r>
              <a:endParaRPr lang="en-US" altLang="ko-KR" sz="900" b="0" dirty="0"/>
            </a:p>
          </p:txBody>
        </p:sp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B9593BBB-96BF-887B-6653-5544337C5423}"/>
                </a:ext>
              </a:extLst>
            </p:cNvPr>
            <p:cNvSpPr/>
            <p:nvPr/>
          </p:nvSpPr>
          <p:spPr>
            <a:xfrm>
              <a:off x="1998908" y="926626"/>
              <a:ext cx="996454" cy="5715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" name="제목 2">
              <a:extLst>
                <a:ext uri="{FF2B5EF4-FFF2-40B4-BE49-F238E27FC236}">
                  <a16:creationId xmlns:a16="http://schemas.microsoft.com/office/drawing/2014/main" id="{199D1203-5C9D-FCD3-FCCE-412A802BE79C}"/>
                </a:ext>
              </a:extLst>
            </p:cNvPr>
            <p:cNvSpPr txBox="1">
              <a:spLocks/>
            </p:cNvSpPr>
            <p:nvPr/>
          </p:nvSpPr>
          <p:spPr>
            <a:xfrm>
              <a:off x="2021018" y="968189"/>
              <a:ext cx="1004386" cy="157882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Gene list</a:t>
              </a:r>
              <a:r>
                <a:rPr lang="ko-KR" altLang="en-US" sz="900" b="0" dirty="0"/>
                <a:t> </a:t>
              </a:r>
              <a:r>
                <a:rPr lang="en-US" altLang="ko-KR" sz="900" b="0" dirty="0"/>
                <a:t>size</a:t>
              </a:r>
            </a:p>
          </p:txBody>
        </p:sp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878F6D97-A77E-E52D-CD18-A8BB97FF7F8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39332" y="1130155"/>
              <a:ext cx="923925" cy="590550"/>
            </a:xfrm>
            <a:prstGeom prst="rect">
              <a:avLst/>
            </a:prstGeom>
          </p:spPr>
        </p:pic>
        <p:graphicFrame>
          <p:nvGraphicFramePr>
            <p:cNvPr id="22" name="차트 21">
              <a:extLst>
                <a:ext uri="{FF2B5EF4-FFF2-40B4-BE49-F238E27FC236}">
                  <a16:creationId xmlns:a16="http://schemas.microsoft.com/office/drawing/2014/main" id="{D1C3E6C9-6FF1-47BA-9E8A-F5609AE5562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2892148"/>
                </p:ext>
              </p:extLst>
            </p:nvPr>
          </p:nvGraphicFramePr>
          <p:xfrm>
            <a:off x="3723034" y="817435"/>
            <a:ext cx="1943100" cy="1447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AD6B2C18-6F80-BD8F-D197-456E67B7D34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67824" y="2724181"/>
              <a:ext cx="1800225" cy="1257300"/>
            </a:xfrm>
            <a:prstGeom prst="rect">
              <a:avLst/>
            </a:prstGeom>
          </p:spPr>
        </p:pic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D2B167AE-571F-89B3-D32F-AE3277767C60}"/>
                </a:ext>
              </a:extLst>
            </p:cNvPr>
            <p:cNvSpPr/>
            <p:nvPr/>
          </p:nvSpPr>
          <p:spPr>
            <a:xfrm>
              <a:off x="1994975" y="2795499"/>
              <a:ext cx="996454" cy="5715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제목 2">
              <a:extLst>
                <a:ext uri="{FF2B5EF4-FFF2-40B4-BE49-F238E27FC236}">
                  <a16:creationId xmlns:a16="http://schemas.microsoft.com/office/drawing/2014/main" id="{9F82BBC1-EB4E-DABE-1368-6F67D1CC4DD3}"/>
                </a:ext>
              </a:extLst>
            </p:cNvPr>
            <p:cNvSpPr txBox="1">
              <a:spLocks/>
            </p:cNvSpPr>
            <p:nvPr/>
          </p:nvSpPr>
          <p:spPr>
            <a:xfrm>
              <a:off x="2055185" y="2846587"/>
              <a:ext cx="1004386" cy="157882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Gene list</a:t>
              </a:r>
              <a:r>
                <a:rPr lang="ko-KR" altLang="en-US" sz="900" b="0" dirty="0"/>
                <a:t> </a:t>
              </a:r>
              <a:r>
                <a:rPr lang="en-US" altLang="ko-KR" sz="900" b="0" dirty="0"/>
                <a:t>size</a:t>
              </a:r>
            </a:p>
          </p:txBody>
        </p:sp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00E8024E-F78E-4262-57E0-321CCB8706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51328" y="3015856"/>
              <a:ext cx="923925" cy="590550"/>
            </a:xfrm>
            <a:prstGeom prst="rect">
              <a:avLst/>
            </a:prstGeom>
          </p:spPr>
        </p:pic>
        <p:sp>
          <p:nvSpPr>
            <p:cNvPr id="14" name="제목 2">
              <a:extLst>
                <a:ext uri="{FF2B5EF4-FFF2-40B4-BE49-F238E27FC236}">
                  <a16:creationId xmlns:a16="http://schemas.microsoft.com/office/drawing/2014/main" id="{1D5B2F5D-0DC8-D6A1-DC37-9A0E59020186}"/>
                </a:ext>
              </a:extLst>
            </p:cNvPr>
            <p:cNvSpPr txBox="1">
              <a:spLocks/>
            </p:cNvSpPr>
            <p:nvPr/>
          </p:nvSpPr>
          <p:spPr>
            <a:xfrm>
              <a:off x="1862901" y="4073744"/>
              <a:ext cx="711179" cy="167369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</a:t>
              </a:r>
              <a:r>
                <a:rPr lang="en-US" altLang="ko-KR" sz="900" b="0" i="1" dirty="0"/>
                <a:t>T</a:t>
              </a:r>
              <a:r>
                <a:rPr lang="en-US" altLang="ko-KR" sz="1100" b="0" i="1" baseline="-25000" dirty="0"/>
                <a:t>w</a:t>
              </a:r>
              <a:r>
                <a:rPr lang="en-US" altLang="ko-KR" sz="900" b="0" i="1" baseline="-25000" dirty="0"/>
                <a:t>  </a:t>
              </a:r>
              <a:r>
                <a:rPr lang="en-US" altLang="ko-KR" sz="900" b="0" dirty="0"/>
                <a:t>of HPO</a:t>
              </a:r>
            </a:p>
          </p:txBody>
        </p:sp>
        <p:sp>
          <p:nvSpPr>
            <p:cNvPr id="15" name="제목 2">
              <a:extLst>
                <a:ext uri="{FF2B5EF4-FFF2-40B4-BE49-F238E27FC236}">
                  <a16:creationId xmlns:a16="http://schemas.microsoft.com/office/drawing/2014/main" id="{AA41F15B-3C59-2096-13DF-481AF3610C2A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670514" y="3302629"/>
              <a:ext cx="1004386" cy="157882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Probability</a:t>
              </a:r>
              <a:r>
                <a:rPr lang="ko-KR" altLang="en-US" sz="900" b="0" dirty="0"/>
                <a:t> </a:t>
              </a:r>
              <a:r>
                <a:rPr lang="en-US" altLang="ko-KR" sz="900" b="0" dirty="0"/>
                <a:t>density</a:t>
              </a:r>
              <a:r>
                <a:rPr lang="en-US" altLang="ko-KR" sz="900" b="0" baseline="-25000" dirty="0"/>
                <a:t>  </a:t>
              </a:r>
              <a:endParaRPr lang="en-US" altLang="ko-KR" sz="900" b="0" dirty="0"/>
            </a:p>
          </p:txBody>
        </p:sp>
        <p:graphicFrame>
          <p:nvGraphicFramePr>
            <p:cNvPr id="19" name="차트 18">
              <a:extLst>
                <a:ext uri="{FF2B5EF4-FFF2-40B4-BE49-F238E27FC236}">
                  <a16:creationId xmlns:a16="http://schemas.microsoft.com/office/drawing/2014/main" id="{58683759-916B-6C84-4CA7-F386408D489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07563899"/>
                </p:ext>
              </p:extLst>
            </p:nvPr>
          </p:nvGraphicFramePr>
          <p:xfrm>
            <a:off x="3734269" y="2670959"/>
            <a:ext cx="1962150" cy="13906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1" name="제목 2">
              <a:extLst>
                <a:ext uri="{FF2B5EF4-FFF2-40B4-BE49-F238E27FC236}">
                  <a16:creationId xmlns:a16="http://schemas.microsoft.com/office/drawing/2014/main" id="{C0AE87AB-3535-FA68-F925-4B8C16DC8676}"/>
                </a:ext>
              </a:extLst>
            </p:cNvPr>
            <p:cNvSpPr txBox="1">
              <a:spLocks/>
            </p:cNvSpPr>
            <p:nvPr/>
          </p:nvSpPr>
          <p:spPr>
            <a:xfrm>
              <a:off x="3972483" y="3991044"/>
              <a:ext cx="1647158" cy="214386"/>
            </a:xfrm>
            <a:prstGeom prst="rect">
              <a:avLst/>
            </a:prstGeom>
          </p:spPr>
          <p:txBody>
            <a:bodyPr vert="horz" lIns="91440" tIns="45721" rIns="91440" bIns="45721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r>
                <a:rPr lang="en-US" altLang="ko-KR" sz="900" b="0" dirty="0"/>
                <a:t># genes on HPO networks</a:t>
              </a:r>
            </a:p>
          </p:txBody>
        </p:sp>
        <p:sp>
          <p:nvSpPr>
            <p:cNvPr id="29" name="제목 2">
              <a:extLst>
                <a:ext uri="{FF2B5EF4-FFF2-40B4-BE49-F238E27FC236}">
                  <a16:creationId xmlns:a16="http://schemas.microsoft.com/office/drawing/2014/main" id="{A64B298B-2D58-4CD6-CC65-342C63918ADC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170325" y="3253220"/>
              <a:ext cx="863863" cy="167735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</a:t>
              </a:r>
              <a:r>
                <a:rPr lang="en-US" altLang="ko-KR" sz="900" b="0" i="1" dirty="0"/>
                <a:t>T</a:t>
              </a:r>
              <a:r>
                <a:rPr lang="en-US" altLang="ko-KR" sz="1100" b="0" i="1" baseline="-25000" dirty="0"/>
                <a:t>w</a:t>
              </a:r>
              <a:r>
                <a:rPr lang="en-US" altLang="ko-KR" sz="900" b="0" i="1" baseline="-25000" dirty="0"/>
                <a:t>  </a:t>
              </a:r>
              <a:endParaRPr lang="en-US" altLang="ko-KR" sz="900" b="0" dirty="0"/>
            </a:p>
          </p:txBody>
        </p:sp>
        <p:sp>
          <p:nvSpPr>
            <p:cNvPr id="32" name="제목 2">
              <a:extLst>
                <a:ext uri="{FF2B5EF4-FFF2-40B4-BE49-F238E27FC236}">
                  <a16:creationId xmlns:a16="http://schemas.microsoft.com/office/drawing/2014/main" id="{207C1093-9246-3832-70F8-3EDBF12742E9}"/>
                </a:ext>
              </a:extLst>
            </p:cNvPr>
            <p:cNvSpPr txBox="1">
              <a:spLocks/>
            </p:cNvSpPr>
            <p:nvPr/>
          </p:nvSpPr>
          <p:spPr>
            <a:xfrm>
              <a:off x="1863480" y="2210064"/>
              <a:ext cx="711179" cy="167369"/>
            </a:xfrm>
            <a:prstGeom prst="rect">
              <a:avLst/>
            </a:prstGeom>
          </p:spPr>
          <p:txBody>
            <a:bodyPr vert="horz" lIns="0" tIns="0" rIns="0" bIns="0" rtlCol="0" anchor="t">
              <a:noAutofit/>
            </a:bodyPr>
            <a:lstStyle>
              <a:lvl1pPr algn="l" defTabSz="914400" rtl="0" eaLnBrk="1" latinLnBrk="1" hangingPunct="1">
                <a:lnSpc>
                  <a:spcPct val="90000"/>
                </a:lnSpc>
                <a:spcBef>
                  <a:spcPct val="0"/>
                </a:spcBef>
                <a:buNone/>
                <a:defRPr sz="2400" b="1" kern="1200">
                  <a:solidFill>
                    <a:schemeClr val="tx1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ko-KR" sz="900" b="0" dirty="0"/>
                <a:t> </a:t>
              </a:r>
              <a:r>
                <a:rPr lang="en-US" altLang="ko-KR" sz="900" b="0" i="1" dirty="0"/>
                <a:t>T</a:t>
              </a:r>
              <a:r>
                <a:rPr lang="en-US" altLang="ko-KR" sz="1100" b="0" i="1" baseline="-25000" dirty="0"/>
                <a:t>w</a:t>
              </a:r>
              <a:r>
                <a:rPr lang="en-US" altLang="ko-KR" sz="900" b="0" i="1" baseline="-25000" dirty="0"/>
                <a:t>  </a:t>
              </a:r>
              <a:r>
                <a:rPr lang="en-US" altLang="ko-KR" sz="900" b="0" dirty="0"/>
                <a:t>of GOB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17795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3C8D44-21AB-193A-DF3F-6F85DFB7072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그림 28">
            <a:extLst>
              <a:ext uri="{FF2B5EF4-FFF2-40B4-BE49-F238E27FC236}">
                <a16:creationId xmlns:a16="http://schemas.microsoft.com/office/drawing/2014/main" id="{00000000-0008-0000-0500-000024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7515" y="2656349"/>
            <a:ext cx="2175034" cy="14500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00000000-0008-0000-0400-00000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0785" y="766812"/>
            <a:ext cx="2102283" cy="14015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제목 2">
            <a:extLst>
              <a:ext uri="{FF2B5EF4-FFF2-40B4-BE49-F238E27FC236}">
                <a16:creationId xmlns:a16="http://schemas.microsoft.com/office/drawing/2014/main" id="{F657FA9B-C849-57A1-E95B-652B411063CA}"/>
              </a:ext>
            </a:extLst>
          </p:cNvPr>
          <p:cNvSpPr txBox="1">
            <a:spLocks/>
          </p:cNvSpPr>
          <p:nvPr/>
        </p:nvSpPr>
        <p:spPr>
          <a:xfrm>
            <a:off x="676487" y="4669608"/>
            <a:ext cx="5710912" cy="1902642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ko-KR" sz="1050" dirty="0"/>
              <a:t>Supplementary Figure 2. Distribution of regular Tanimoto scores (</a:t>
            </a:r>
            <a:r>
              <a:rPr lang="en-US" altLang="ko-KR" sz="1050" i="1" dirty="0"/>
              <a:t>T</a:t>
            </a:r>
            <a:r>
              <a:rPr lang="en-US" altLang="ko-KR" sz="1050" dirty="0"/>
              <a:t>) in ontology clusters. </a:t>
            </a:r>
            <a:r>
              <a:rPr lang="en-US" altLang="ko-KR" sz="1050" b="0" dirty="0"/>
              <a:t>Ontology clusters were constructed using randomly selected ontology lists of varying sizes. For each ontology group ranging from 10 to 1,000 terms, a total of 10,000 clustered networks were generated. </a:t>
            </a:r>
            <a:r>
              <a:rPr lang="en-US" altLang="ko-KR" sz="1050" b="0" dirty="0">
                <a:solidFill>
                  <a:srgbClr val="FF0000"/>
                </a:solidFill>
              </a:rPr>
              <a:t>(A, C) Probability density distributions of T scores based on </a:t>
            </a:r>
            <a:r>
              <a:rPr lang="en-US" altLang="ko-KR" sz="1050" b="0" dirty="0" err="1">
                <a:solidFill>
                  <a:srgbClr val="FF0000"/>
                </a:solidFill>
              </a:rPr>
              <a:t>GOBP</a:t>
            </a:r>
            <a:r>
              <a:rPr lang="en-US" altLang="ko-KR" sz="1050" b="0" dirty="0">
                <a:solidFill>
                  <a:srgbClr val="FF0000"/>
                </a:solidFill>
              </a:rPr>
              <a:t> and </a:t>
            </a:r>
            <a:r>
              <a:rPr lang="en-US" altLang="ko-KR" sz="1050" b="0" dirty="0" err="1">
                <a:solidFill>
                  <a:srgbClr val="FF0000"/>
                </a:solidFill>
              </a:rPr>
              <a:t>HPO</a:t>
            </a:r>
            <a:r>
              <a:rPr lang="en-US" altLang="ko-KR" sz="1050" b="0" dirty="0">
                <a:solidFill>
                  <a:srgbClr val="FF0000"/>
                </a:solidFill>
              </a:rPr>
              <a:t>, respectively. (B, D) Top 1–15% T score cutoff values across different ontology list sizes for </a:t>
            </a:r>
            <a:r>
              <a:rPr lang="en-US" altLang="ko-KR" sz="1050" b="0" dirty="0" err="1">
                <a:solidFill>
                  <a:srgbClr val="FF0000"/>
                </a:solidFill>
              </a:rPr>
              <a:t>GOBP</a:t>
            </a:r>
            <a:r>
              <a:rPr lang="en-US" altLang="ko-KR" sz="1050" b="0" dirty="0">
                <a:solidFill>
                  <a:srgbClr val="FF0000"/>
                </a:solidFill>
              </a:rPr>
              <a:t>- and </a:t>
            </a:r>
            <a:r>
              <a:rPr lang="en-US" altLang="ko-KR" sz="1050" b="0" dirty="0" err="1">
                <a:solidFill>
                  <a:srgbClr val="FF0000"/>
                </a:solidFill>
              </a:rPr>
              <a:t>HPO</a:t>
            </a:r>
            <a:r>
              <a:rPr lang="en-US" altLang="ko-KR" sz="1050" b="0" dirty="0">
                <a:solidFill>
                  <a:srgbClr val="FF0000"/>
                </a:solidFill>
              </a:rPr>
              <a:t>-based clusters, respectively. These simulations were performed to characterize the expected distribution of T scores across ontology-list sizes and to derive list-size–dependent T cutoffs. The figure summarizes the range of T values and the corresponding upper-quantile thresholds used for ontology clustering and functional interpretation.</a:t>
            </a:r>
          </a:p>
        </p:txBody>
      </p:sp>
      <p:sp>
        <p:nvSpPr>
          <p:cNvPr id="10" name="제목 2">
            <a:extLst>
              <a:ext uri="{FF2B5EF4-FFF2-40B4-BE49-F238E27FC236}">
                <a16:creationId xmlns:a16="http://schemas.microsoft.com/office/drawing/2014/main" id="{35D45944-BFB1-1D1B-687A-438B9DC34AF3}"/>
              </a:ext>
            </a:extLst>
          </p:cNvPr>
          <p:cNvSpPr txBox="1">
            <a:spLocks/>
          </p:cNvSpPr>
          <p:nvPr/>
        </p:nvSpPr>
        <p:spPr>
          <a:xfrm>
            <a:off x="654564" y="2475549"/>
            <a:ext cx="167735" cy="138628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1001" b="0" dirty="0"/>
              <a:t>(C)</a:t>
            </a:r>
          </a:p>
        </p:txBody>
      </p:sp>
      <p:sp>
        <p:nvSpPr>
          <p:cNvPr id="11" name="제목 2">
            <a:extLst>
              <a:ext uri="{FF2B5EF4-FFF2-40B4-BE49-F238E27FC236}">
                <a16:creationId xmlns:a16="http://schemas.microsoft.com/office/drawing/2014/main" id="{DA1540FB-690A-1B87-7A62-97718E2E7EFA}"/>
              </a:ext>
            </a:extLst>
          </p:cNvPr>
          <p:cNvSpPr txBox="1">
            <a:spLocks/>
          </p:cNvSpPr>
          <p:nvPr/>
        </p:nvSpPr>
        <p:spPr>
          <a:xfrm>
            <a:off x="676487" y="516080"/>
            <a:ext cx="167735" cy="138628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1001" b="0" dirty="0"/>
              <a:t>(A)</a:t>
            </a:r>
          </a:p>
        </p:txBody>
      </p:sp>
      <p:sp>
        <p:nvSpPr>
          <p:cNvPr id="14" name="제목 2">
            <a:extLst>
              <a:ext uri="{FF2B5EF4-FFF2-40B4-BE49-F238E27FC236}">
                <a16:creationId xmlns:a16="http://schemas.microsoft.com/office/drawing/2014/main" id="{FCA51DB9-011F-7B20-2FCD-04BE222843D4}"/>
              </a:ext>
            </a:extLst>
          </p:cNvPr>
          <p:cNvSpPr txBox="1">
            <a:spLocks/>
          </p:cNvSpPr>
          <p:nvPr/>
        </p:nvSpPr>
        <p:spPr>
          <a:xfrm>
            <a:off x="4243304" y="2133097"/>
            <a:ext cx="1813495" cy="219882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900" b="0" dirty="0"/>
              <a:t># 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functions on GOBP clusters</a:t>
            </a:r>
          </a:p>
        </p:txBody>
      </p:sp>
      <p:sp>
        <p:nvSpPr>
          <p:cNvPr id="15" name="제목 2">
            <a:extLst>
              <a:ext uri="{FF2B5EF4-FFF2-40B4-BE49-F238E27FC236}">
                <a16:creationId xmlns:a16="http://schemas.microsoft.com/office/drawing/2014/main" id="{65D6CF3E-A27A-69CF-94E8-0922C4D557F9}"/>
              </a:ext>
            </a:extLst>
          </p:cNvPr>
          <p:cNvSpPr txBox="1">
            <a:spLocks/>
          </p:cNvSpPr>
          <p:nvPr/>
        </p:nvSpPr>
        <p:spPr>
          <a:xfrm rot="16200000">
            <a:off x="3766857" y="1245530"/>
            <a:ext cx="295515" cy="117989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i="1" dirty="0"/>
              <a:t>T</a:t>
            </a:r>
            <a:endParaRPr lang="en-US" altLang="ko-KR" sz="900" b="0" dirty="0"/>
          </a:p>
        </p:txBody>
      </p:sp>
      <p:sp>
        <p:nvSpPr>
          <p:cNvPr id="16" name="제목 2">
            <a:extLst>
              <a:ext uri="{FF2B5EF4-FFF2-40B4-BE49-F238E27FC236}">
                <a16:creationId xmlns:a16="http://schemas.microsoft.com/office/drawing/2014/main" id="{C005E4C4-475F-07D1-580F-B5B4527412AE}"/>
              </a:ext>
            </a:extLst>
          </p:cNvPr>
          <p:cNvSpPr txBox="1">
            <a:spLocks/>
          </p:cNvSpPr>
          <p:nvPr/>
        </p:nvSpPr>
        <p:spPr>
          <a:xfrm>
            <a:off x="3548034" y="516080"/>
            <a:ext cx="167735" cy="138628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1001" b="0" dirty="0"/>
              <a:t>(B)</a:t>
            </a:r>
          </a:p>
        </p:txBody>
      </p:sp>
      <p:sp>
        <p:nvSpPr>
          <p:cNvPr id="5" name="제목 2">
            <a:extLst>
              <a:ext uri="{FF2B5EF4-FFF2-40B4-BE49-F238E27FC236}">
                <a16:creationId xmlns:a16="http://schemas.microsoft.com/office/drawing/2014/main" id="{E37C19E4-089B-CDC1-844F-A5885C6C2B20}"/>
              </a:ext>
            </a:extLst>
          </p:cNvPr>
          <p:cNvSpPr txBox="1">
            <a:spLocks/>
          </p:cNvSpPr>
          <p:nvPr/>
        </p:nvSpPr>
        <p:spPr>
          <a:xfrm>
            <a:off x="3548034" y="2544863"/>
            <a:ext cx="167735" cy="138628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1001" b="0" dirty="0"/>
              <a:t>(D)</a:t>
            </a:r>
          </a:p>
        </p:txBody>
      </p:sp>
      <p:sp>
        <p:nvSpPr>
          <p:cNvPr id="8" name="제목 2">
            <a:extLst>
              <a:ext uri="{FF2B5EF4-FFF2-40B4-BE49-F238E27FC236}">
                <a16:creationId xmlns:a16="http://schemas.microsoft.com/office/drawing/2014/main" id="{BB71F907-654B-AF0B-A7D9-73AAA8D0AC5D}"/>
              </a:ext>
            </a:extLst>
          </p:cNvPr>
          <p:cNvSpPr txBox="1">
            <a:spLocks/>
          </p:cNvSpPr>
          <p:nvPr/>
        </p:nvSpPr>
        <p:spPr>
          <a:xfrm>
            <a:off x="4209194" y="4123837"/>
            <a:ext cx="1813495" cy="219882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ko-KR" sz="900" b="0" dirty="0"/>
              <a:t># 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phenotypes on HPO clusters</a:t>
            </a:r>
          </a:p>
        </p:txBody>
      </p:sp>
      <p:sp>
        <p:nvSpPr>
          <p:cNvPr id="12" name="제목 2">
            <a:extLst>
              <a:ext uri="{FF2B5EF4-FFF2-40B4-BE49-F238E27FC236}">
                <a16:creationId xmlns:a16="http://schemas.microsoft.com/office/drawing/2014/main" id="{5CD85A69-78E1-6380-84BD-A0DF892601F9}"/>
              </a:ext>
            </a:extLst>
          </p:cNvPr>
          <p:cNvSpPr txBox="1">
            <a:spLocks/>
          </p:cNvSpPr>
          <p:nvPr/>
        </p:nvSpPr>
        <p:spPr>
          <a:xfrm rot="16200000">
            <a:off x="3766857" y="3214184"/>
            <a:ext cx="295515" cy="117989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i="1" dirty="0"/>
              <a:t>T</a:t>
            </a:r>
            <a:endParaRPr lang="en-US" altLang="ko-KR" sz="900" b="0" dirty="0"/>
          </a:p>
        </p:txBody>
      </p:sp>
      <p:sp>
        <p:nvSpPr>
          <p:cNvPr id="18" name="제목 2">
            <a:extLst>
              <a:ext uri="{FF2B5EF4-FFF2-40B4-BE49-F238E27FC236}">
                <a16:creationId xmlns:a16="http://schemas.microsoft.com/office/drawing/2014/main" id="{D333DFD7-241A-F55B-8AB0-CCB72AD3FA8E}"/>
              </a:ext>
            </a:extLst>
          </p:cNvPr>
          <p:cNvSpPr txBox="1">
            <a:spLocks/>
          </p:cNvSpPr>
          <p:nvPr/>
        </p:nvSpPr>
        <p:spPr>
          <a:xfrm rot="16200000">
            <a:off x="517926" y="1416484"/>
            <a:ext cx="1004386" cy="157882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Probability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density</a:t>
            </a:r>
            <a:r>
              <a:rPr lang="en-US" altLang="ko-KR" sz="900" b="0" baseline="-25000" dirty="0"/>
              <a:t>  </a:t>
            </a:r>
            <a:endParaRPr lang="en-US" altLang="ko-KR" sz="900" b="0" dirty="0"/>
          </a:p>
        </p:txBody>
      </p:sp>
      <p:sp>
        <p:nvSpPr>
          <p:cNvPr id="19" name="제목 2">
            <a:extLst>
              <a:ext uri="{FF2B5EF4-FFF2-40B4-BE49-F238E27FC236}">
                <a16:creationId xmlns:a16="http://schemas.microsoft.com/office/drawing/2014/main" id="{C005BA7D-1804-D9AE-23E7-CD9B1ED99AA6}"/>
              </a:ext>
            </a:extLst>
          </p:cNvPr>
          <p:cNvSpPr txBox="1">
            <a:spLocks/>
          </p:cNvSpPr>
          <p:nvPr/>
        </p:nvSpPr>
        <p:spPr>
          <a:xfrm rot="16200000">
            <a:off x="504479" y="3337298"/>
            <a:ext cx="1004386" cy="157882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Probability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density</a:t>
            </a:r>
            <a:r>
              <a:rPr lang="en-US" altLang="ko-KR" sz="900" b="0" baseline="-25000" dirty="0"/>
              <a:t>  </a:t>
            </a:r>
            <a:endParaRPr lang="en-US" altLang="ko-KR" sz="900" b="0" dirty="0"/>
          </a:p>
        </p:txBody>
      </p:sp>
      <p:sp>
        <p:nvSpPr>
          <p:cNvPr id="20" name="제목 2">
            <a:extLst>
              <a:ext uri="{FF2B5EF4-FFF2-40B4-BE49-F238E27FC236}">
                <a16:creationId xmlns:a16="http://schemas.microsoft.com/office/drawing/2014/main" id="{EC413B50-6D62-2A17-BD70-AC3BDCCE2288}"/>
              </a:ext>
            </a:extLst>
          </p:cNvPr>
          <p:cNvSpPr txBox="1">
            <a:spLocks/>
          </p:cNvSpPr>
          <p:nvPr/>
        </p:nvSpPr>
        <p:spPr>
          <a:xfrm>
            <a:off x="1903518" y="2234425"/>
            <a:ext cx="711179" cy="167369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</a:t>
            </a:r>
            <a:r>
              <a:rPr lang="en-US" altLang="ko-KR" sz="900" b="0" i="1" dirty="0"/>
              <a:t>T</a:t>
            </a:r>
            <a:r>
              <a:rPr lang="en-US" altLang="ko-KR" sz="900" b="0" i="1" baseline="-25000" dirty="0"/>
              <a:t>  </a:t>
            </a:r>
            <a:r>
              <a:rPr lang="en-US" altLang="ko-KR" sz="900" b="0" dirty="0"/>
              <a:t>of GOBP</a:t>
            </a:r>
          </a:p>
        </p:txBody>
      </p:sp>
      <p:sp>
        <p:nvSpPr>
          <p:cNvPr id="21" name="제목 2">
            <a:extLst>
              <a:ext uri="{FF2B5EF4-FFF2-40B4-BE49-F238E27FC236}">
                <a16:creationId xmlns:a16="http://schemas.microsoft.com/office/drawing/2014/main" id="{F0EE1995-0214-25E4-BE6B-8B813AE00A0F}"/>
              </a:ext>
            </a:extLst>
          </p:cNvPr>
          <p:cNvSpPr txBox="1">
            <a:spLocks/>
          </p:cNvSpPr>
          <p:nvPr/>
        </p:nvSpPr>
        <p:spPr>
          <a:xfrm>
            <a:off x="1772690" y="4177492"/>
            <a:ext cx="711179" cy="167369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</a:t>
            </a:r>
            <a:r>
              <a:rPr lang="en-US" altLang="ko-KR" sz="900" b="0" i="1" dirty="0"/>
              <a:t>T</a:t>
            </a:r>
            <a:r>
              <a:rPr lang="en-US" altLang="ko-KR" sz="900" b="0" i="1" baseline="-25000" dirty="0"/>
              <a:t>  </a:t>
            </a:r>
            <a:r>
              <a:rPr lang="en-US" altLang="ko-KR" sz="900" b="0" dirty="0"/>
              <a:t>of HPO</a:t>
            </a: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5DA03839-E0D1-C432-51D4-27991146E92D}"/>
              </a:ext>
            </a:extLst>
          </p:cNvPr>
          <p:cNvSpPr/>
          <p:nvPr/>
        </p:nvSpPr>
        <p:spPr>
          <a:xfrm>
            <a:off x="2078207" y="862882"/>
            <a:ext cx="996454" cy="571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DCCF464C-A05D-D470-7B38-A652A85B1E45}"/>
              </a:ext>
            </a:extLst>
          </p:cNvPr>
          <p:cNvSpPr/>
          <p:nvPr/>
        </p:nvSpPr>
        <p:spPr>
          <a:xfrm>
            <a:off x="2037951" y="2769276"/>
            <a:ext cx="996454" cy="571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C96E81BB-F801-0723-DCB8-2535E4EDA3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92287" y="3016789"/>
            <a:ext cx="923925" cy="590550"/>
          </a:xfrm>
          <a:prstGeom prst="rect">
            <a:avLst/>
          </a:prstGeom>
        </p:spPr>
      </p:pic>
      <p:sp>
        <p:nvSpPr>
          <p:cNvPr id="2" name="제목 2">
            <a:extLst>
              <a:ext uri="{FF2B5EF4-FFF2-40B4-BE49-F238E27FC236}">
                <a16:creationId xmlns:a16="http://schemas.microsoft.com/office/drawing/2014/main" id="{371E1698-7B7F-8A77-C45A-57ED7EE9592F}"/>
              </a:ext>
            </a:extLst>
          </p:cNvPr>
          <p:cNvSpPr txBox="1">
            <a:spLocks/>
          </p:cNvSpPr>
          <p:nvPr/>
        </p:nvSpPr>
        <p:spPr>
          <a:xfrm>
            <a:off x="2033985" y="2815327"/>
            <a:ext cx="1004386" cy="157882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Ontology list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size</a:t>
            </a:r>
          </a:p>
        </p:txBody>
      </p:sp>
      <p:sp>
        <p:nvSpPr>
          <p:cNvPr id="7" name="제목 2">
            <a:extLst>
              <a:ext uri="{FF2B5EF4-FFF2-40B4-BE49-F238E27FC236}">
                <a16:creationId xmlns:a16="http://schemas.microsoft.com/office/drawing/2014/main" id="{CB97DE4A-3AFA-DFA6-DE16-8F47EF255504}"/>
              </a:ext>
            </a:extLst>
          </p:cNvPr>
          <p:cNvSpPr txBox="1">
            <a:spLocks/>
          </p:cNvSpPr>
          <p:nvPr/>
        </p:nvSpPr>
        <p:spPr>
          <a:xfrm>
            <a:off x="2033985" y="896421"/>
            <a:ext cx="1004386" cy="157882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altLang="ko-KR" sz="900" b="0" dirty="0"/>
              <a:t> Ontology list</a:t>
            </a:r>
            <a:r>
              <a:rPr lang="ko-KR" altLang="en-US" sz="900" b="0" dirty="0"/>
              <a:t> </a:t>
            </a:r>
            <a:r>
              <a:rPr lang="en-US" altLang="ko-KR" sz="900" b="0" dirty="0"/>
              <a:t>size</a:t>
            </a:r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31428456-9797-A755-2FDB-0288DF9C529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74215" y="1064880"/>
            <a:ext cx="923925" cy="590550"/>
          </a:xfrm>
          <a:prstGeom prst="rect">
            <a:avLst/>
          </a:prstGeom>
        </p:spPr>
      </p:pic>
      <p:graphicFrame>
        <p:nvGraphicFramePr>
          <p:cNvPr id="25" name="차트 24">
            <a:extLst>
              <a:ext uri="{FF2B5EF4-FFF2-40B4-BE49-F238E27FC236}">
                <a16:creationId xmlns:a16="http://schemas.microsoft.com/office/drawing/2014/main" id="{63037767-CEB5-4017-972B-DA3EB68BB7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389197"/>
              </p:ext>
            </p:extLst>
          </p:nvPr>
        </p:nvGraphicFramePr>
        <p:xfrm>
          <a:off x="4013635" y="838698"/>
          <a:ext cx="1962150" cy="1314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차트 26">
            <a:extLst>
              <a:ext uri="{FF2B5EF4-FFF2-40B4-BE49-F238E27FC236}">
                <a16:creationId xmlns:a16="http://schemas.microsoft.com/office/drawing/2014/main" id="{B2B0763A-A9D5-4636-9FA0-E60671ECFA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9501198"/>
              </p:ext>
            </p:extLst>
          </p:nvPr>
        </p:nvGraphicFramePr>
        <p:xfrm>
          <a:off x="4009800" y="2708986"/>
          <a:ext cx="1952624" cy="1447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9926451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65938D-54C9-A80D-5594-66E3E409DA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2156C846-7230-F522-FCB4-7CC7261D9D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7608" y="3178351"/>
            <a:ext cx="3902716" cy="1932844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23BA0CEA-A0EC-F9B8-805A-029F11E365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1035" y="620974"/>
            <a:ext cx="2394257" cy="2237898"/>
          </a:xfrm>
          <a:prstGeom prst="rect">
            <a:avLst/>
          </a:prstGeom>
        </p:spPr>
      </p:pic>
      <p:sp>
        <p:nvSpPr>
          <p:cNvPr id="28" name="제목 2">
            <a:extLst>
              <a:ext uri="{FF2B5EF4-FFF2-40B4-BE49-F238E27FC236}">
                <a16:creationId xmlns:a16="http://schemas.microsoft.com/office/drawing/2014/main" id="{43148651-FCF9-EDC1-282F-385E010DFA6F}"/>
              </a:ext>
            </a:extLst>
          </p:cNvPr>
          <p:cNvSpPr txBox="1">
            <a:spLocks/>
          </p:cNvSpPr>
          <p:nvPr/>
        </p:nvSpPr>
        <p:spPr>
          <a:xfrm>
            <a:off x="2968909" y="723038"/>
            <a:ext cx="1673844" cy="264185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TP53 target network</a:t>
            </a:r>
          </a:p>
        </p:txBody>
      </p:sp>
      <p:sp>
        <p:nvSpPr>
          <p:cNvPr id="47" name="제목 2">
            <a:extLst>
              <a:ext uri="{FF2B5EF4-FFF2-40B4-BE49-F238E27FC236}">
                <a16:creationId xmlns:a16="http://schemas.microsoft.com/office/drawing/2014/main" id="{7EA4D5F9-D583-633F-17EE-2FBF99DC0BE9}"/>
              </a:ext>
            </a:extLst>
          </p:cNvPr>
          <p:cNvSpPr txBox="1">
            <a:spLocks/>
          </p:cNvSpPr>
          <p:nvPr/>
        </p:nvSpPr>
        <p:spPr>
          <a:xfrm>
            <a:off x="757608" y="3158523"/>
            <a:ext cx="167734" cy="13849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B)</a:t>
            </a:r>
            <a:endParaRPr kumimoji="0" lang="en-US" altLang="ko-K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/>
              <a:cs typeface="Arial" panose="020B0604020202020204" pitchFamily="34" charset="0"/>
            </a:endParaRPr>
          </a:p>
        </p:txBody>
      </p:sp>
      <p:sp>
        <p:nvSpPr>
          <p:cNvPr id="49" name="제목 2">
            <a:extLst>
              <a:ext uri="{FF2B5EF4-FFF2-40B4-BE49-F238E27FC236}">
                <a16:creationId xmlns:a16="http://schemas.microsoft.com/office/drawing/2014/main" id="{CCB65020-A332-88C8-18F2-998CA5BF7261}"/>
              </a:ext>
            </a:extLst>
          </p:cNvPr>
          <p:cNvSpPr txBox="1">
            <a:spLocks/>
          </p:cNvSpPr>
          <p:nvPr/>
        </p:nvSpPr>
        <p:spPr>
          <a:xfrm>
            <a:off x="760567" y="586852"/>
            <a:ext cx="167734" cy="138499"/>
          </a:xfrm>
          <a:prstGeom prst="rect">
            <a:avLst/>
          </a:prstGeom>
        </p:spPr>
        <p:txBody>
          <a:bodyPr vert="horz" wrap="square" lIns="0" tIns="0" rIns="0" bIns="0" rtlCol="0" anchor="t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7" name="제목 2">
            <a:extLst>
              <a:ext uri="{FF2B5EF4-FFF2-40B4-BE49-F238E27FC236}">
                <a16:creationId xmlns:a16="http://schemas.microsoft.com/office/drawing/2014/main" id="{A7396D61-2C0F-3A65-7EED-85157500DFC6}"/>
              </a:ext>
            </a:extLst>
          </p:cNvPr>
          <p:cNvSpPr txBox="1">
            <a:spLocks/>
          </p:cNvSpPr>
          <p:nvPr/>
        </p:nvSpPr>
        <p:spPr>
          <a:xfrm>
            <a:off x="3156728" y="937901"/>
            <a:ext cx="2939526" cy="253234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l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9 genes connected by 117 </a:t>
            </a:r>
            <a:r>
              <a:rPr lang="en-US" altLang="ko-KR" sz="1000" b="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ncogenic</a:t>
            </a:r>
            <a:r>
              <a:rPr lang="ko-KR" altLang="en-US" sz="1000" b="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ko-KR" sz="1000" b="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gnatures</a:t>
            </a:r>
            <a:r>
              <a:rPr kumimoji="0" lang="en-US" altLang="ko-KR" sz="1000" b="0" i="0" u="non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</p:txBody>
      </p:sp>
      <p:sp>
        <p:nvSpPr>
          <p:cNvPr id="69" name="제목 2">
            <a:extLst>
              <a:ext uri="{FF2B5EF4-FFF2-40B4-BE49-F238E27FC236}">
                <a16:creationId xmlns:a16="http://schemas.microsoft.com/office/drawing/2014/main" id="{0A2F4CC1-E5A8-20AA-115B-A2FECB654AB2}"/>
              </a:ext>
            </a:extLst>
          </p:cNvPr>
          <p:cNvSpPr txBox="1">
            <a:spLocks/>
          </p:cNvSpPr>
          <p:nvPr/>
        </p:nvSpPr>
        <p:spPr>
          <a:xfrm>
            <a:off x="469034" y="6393583"/>
            <a:ext cx="5919931" cy="2341224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ko-KR" sz="1050" dirty="0"/>
              <a:t>Supplementary Figure 3. Decomposition of gene networks and interpretation of “Oncogenic Signatures”</a:t>
            </a:r>
            <a:r>
              <a:rPr lang="en-US" altLang="ko-KR" sz="1050" b="0" dirty="0"/>
              <a:t>. A total of 209 genes, whose CRISPR knockout efficacy is positively associated with TP53 mutations in caner cells, were used for the network construction and interpretation. </a:t>
            </a:r>
            <a:r>
              <a:rPr lang="en-US" altLang="ko-KR" sz="1050" b="0" dirty="0">
                <a:solidFill>
                  <a:srgbClr val="FF0000"/>
                </a:solidFill>
              </a:rPr>
              <a:t>(A) A total of 117 “Oncogenic Signature” terms contributed to edges with Tw &gt; 0. Two representative terms were selected based on enrichment significance (p &lt; 0.01), contribution to edge weights (total Tw &gt; 1), and low redundancy between terms (T &lt; 0.3). (B) The resulting subnetwork illustrates how representative “Oncogenic Signature” terms map onto 40 gene nodes, with ASNS and ADSL appearing as shared nodes across multiple terms. These panels demonstrate that </a:t>
            </a:r>
            <a:r>
              <a:rPr lang="en-US" altLang="ko-KR" sz="1050" b="0" dirty="0" err="1">
                <a:solidFill>
                  <a:srgbClr val="FF0000"/>
                </a:solidFill>
              </a:rPr>
              <a:t>NetCrafter</a:t>
            </a:r>
            <a:r>
              <a:rPr lang="en-US" altLang="ko-KR" sz="1050" b="0" dirty="0">
                <a:solidFill>
                  <a:srgbClr val="FF0000"/>
                </a:solidFill>
              </a:rPr>
              <a:t> can identify representative functional modules and shared hub genes from Oncogenic Signatures.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FDB6FE14-1E9D-B456-8285-0B874EF5FD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2710" y="1860278"/>
            <a:ext cx="2655666" cy="532940"/>
          </a:xfrm>
          <a:prstGeom prst="rect">
            <a:avLst/>
          </a:prstGeom>
          <a:ln w="6350">
            <a:solidFill>
              <a:schemeClr val="accent1"/>
            </a:solidFill>
          </a:ln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FB4156F3-766A-44DD-8893-45D38C6104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19091" y="4466294"/>
            <a:ext cx="2125460" cy="1582109"/>
          </a:xfrm>
          <a:prstGeom prst="rect">
            <a:avLst/>
          </a:prstGeom>
          <a:ln w="6350"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AB852C7-4531-EEF4-AB80-E1E43974326D}"/>
              </a:ext>
            </a:extLst>
          </p:cNvPr>
          <p:cNvSpPr txBox="1"/>
          <p:nvPr/>
        </p:nvSpPr>
        <p:spPr>
          <a:xfrm>
            <a:off x="947667" y="5612441"/>
            <a:ext cx="288925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 Edge t</a:t>
            </a:r>
            <a:r>
              <a:rPr lang="ko-KR" altLang="en-US" sz="800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eshold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w)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0.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800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rm threshold: 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r>
              <a:rPr lang="ko-KR" altLang="en-US" sz="800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ko-KR" altLang="en-US" sz="800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val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,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ko-KR" altLang="en-US" sz="800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ibution &gt;</a:t>
            </a:r>
            <a:r>
              <a:rPr lang="ko-KR" altLang="en-U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pPr algn="r"/>
            <a:r>
              <a:rPr lang="en-US" altLang="ko-KR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     Shared genes between terms (T) &lt; 0.3</a:t>
            </a:r>
            <a:endParaRPr lang="ko-KR" altLang="en-US" sz="800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37E04AF9-288B-03E1-B51E-D90DB6B8F0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47667" y="5000550"/>
            <a:ext cx="1103733" cy="391087"/>
          </a:xfrm>
          <a:prstGeom prst="rect">
            <a:avLst/>
          </a:prstGeom>
          <a:ln w="6350">
            <a:solidFill>
              <a:schemeClr val="bg1">
                <a:lumMod val="50000"/>
              </a:schemeClr>
            </a:solidFill>
          </a:ln>
        </p:spPr>
      </p:pic>
      <p:sp>
        <p:nvSpPr>
          <p:cNvPr id="12" name="제목 2">
            <a:extLst>
              <a:ext uri="{FF2B5EF4-FFF2-40B4-BE49-F238E27FC236}">
                <a16:creationId xmlns:a16="http://schemas.microsoft.com/office/drawing/2014/main" id="{4E410C0B-B5D6-CE7F-38E7-65B7E1E35501}"/>
              </a:ext>
            </a:extLst>
          </p:cNvPr>
          <p:cNvSpPr txBox="1">
            <a:spLocks/>
          </p:cNvSpPr>
          <p:nvPr/>
        </p:nvSpPr>
        <p:spPr>
          <a:xfrm>
            <a:off x="3298851" y="2443193"/>
            <a:ext cx="2978124" cy="330437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 -log(p-value) &gt; 2, total Tw &gt; 1, shared genes (T) &lt; 0.3</a:t>
            </a:r>
          </a:p>
        </p:txBody>
      </p:sp>
      <p:sp>
        <p:nvSpPr>
          <p:cNvPr id="13" name="제목 2">
            <a:extLst>
              <a:ext uri="{FF2B5EF4-FFF2-40B4-BE49-F238E27FC236}">
                <a16:creationId xmlns:a16="http://schemas.microsoft.com/office/drawing/2014/main" id="{65418ABE-CC36-545A-7B23-36F131A21B3A}"/>
              </a:ext>
            </a:extLst>
          </p:cNvPr>
          <p:cNvSpPr txBox="1">
            <a:spLocks/>
          </p:cNvSpPr>
          <p:nvPr/>
        </p:nvSpPr>
        <p:spPr>
          <a:xfrm>
            <a:off x="3079850" y="3147585"/>
            <a:ext cx="2529108" cy="441111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altLang="ko-KR" sz="900" dirty="0"/>
              <a:t>Decomposition of gene networks</a:t>
            </a:r>
            <a:endParaRPr lang="en-US" altLang="ko-KR" sz="900" b="0" dirty="0">
              <a:solidFill>
                <a:prstClr val="black"/>
              </a:solidFill>
            </a:endParaRPr>
          </a:p>
        </p:txBody>
      </p:sp>
      <p:sp useBgFill="1">
        <p:nvSpPr>
          <p:cNvPr id="30" name="제목 2">
            <a:extLst>
              <a:ext uri="{FF2B5EF4-FFF2-40B4-BE49-F238E27FC236}">
                <a16:creationId xmlns:a16="http://schemas.microsoft.com/office/drawing/2014/main" id="{89FDF408-ABA9-96B5-C14A-71456801CEE1}"/>
              </a:ext>
            </a:extLst>
          </p:cNvPr>
          <p:cNvSpPr txBox="1">
            <a:spLocks/>
          </p:cNvSpPr>
          <p:nvPr/>
        </p:nvSpPr>
        <p:spPr>
          <a:xfrm>
            <a:off x="3337449" y="1582531"/>
            <a:ext cx="2610608" cy="280383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algn="ctr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Calibri" panose="020F0502020204030204" pitchFamily="34" charset="0"/>
              </a:rPr>
              <a:t>List of representative ontology terms</a:t>
            </a:r>
          </a:p>
        </p:txBody>
      </p:sp>
      <p:sp>
        <p:nvSpPr>
          <p:cNvPr id="41" name="제목 2">
            <a:extLst>
              <a:ext uri="{FF2B5EF4-FFF2-40B4-BE49-F238E27FC236}">
                <a16:creationId xmlns:a16="http://schemas.microsoft.com/office/drawing/2014/main" id="{C09C3930-14E9-862D-293A-BB4D7112D460}"/>
              </a:ext>
            </a:extLst>
          </p:cNvPr>
          <p:cNvSpPr txBox="1">
            <a:spLocks/>
          </p:cNvSpPr>
          <p:nvPr/>
        </p:nvSpPr>
        <p:spPr>
          <a:xfrm>
            <a:off x="3919091" y="4219003"/>
            <a:ext cx="2255213" cy="330437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marL="0" marR="0" lvl="0" indent="0" defTabSz="9144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Calibri" panose="020F0502020204030204" pitchFamily="34" charset="0"/>
              </a:rPr>
              <a:t>Key terms in the selected subnetwork</a:t>
            </a:r>
          </a:p>
        </p:txBody>
      </p:sp>
      <p:sp>
        <p:nvSpPr>
          <p:cNvPr id="42" name="제목 2">
            <a:extLst>
              <a:ext uri="{FF2B5EF4-FFF2-40B4-BE49-F238E27FC236}">
                <a16:creationId xmlns:a16="http://schemas.microsoft.com/office/drawing/2014/main" id="{423ECDBF-EA06-BA9A-7B52-8297A03AE271}"/>
              </a:ext>
            </a:extLst>
          </p:cNvPr>
          <p:cNvSpPr txBox="1">
            <a:spLocks/>
          </p:cNvSpPr>
          <p:nvPr/>
        </p:nvSpPr>
        <p:spPr>
          <a:xfrm>
            <a:off x="4342393" y="3729670"/>
            <a:ext cx="587245" cy="255247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altLang="ko-KR" sz="800" b="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ADSL</a:t>
            </a:r>
          </a:p>
        </p:txBody>
      </p:sp>
      <p:sp>
        <p:nvSpPr>
          <p:cNvPr id="61" name="제목 2">
            <a:extLst>
              <a:ext uri="{FF2B5EF4-FFF2-40B4-BE49-F238E27FC236}">
                <a16:creationId xmlns:a16="http://schemas.microsoft.com/office/drawing/2014/main" id="{F262EF89-410F-D529-B9D5-D6A102DC6587}"/>
              </a:ext>
            </a:extLst>
          </p:cNvPr>
          <p:cNvSpPr txBox="1">
            <a:spLocks/>
          </p:cNvSpPr>
          <p:nvPr/>
        </p:nvSpPr>
        <p:spPr>
          <a:xfrm>
            <a:off x="2719003" y="3644135"/>
            <a:ext cx="618446" cy="255247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altLang="ko-KR" sz="800" b="0" dirty="0">
                <a:solidFill>
                  <a:schemeClr val="tx1">
                    <a:lumMod val="50000"/>
                    <a:lumOff val="50000"/>
                  </a:schemeClr>
                </a:solidFill>
              </a:rPr>
              <a:t>ASNS</a:t>
            </a:r>
          </a:p>
        </p:txBody>
      </p:sp>
    </p:spTree>
    <p:extLst>
      <p:ext uri="{BB962C8B-B14F-4D97-AF65-F5344CB8AC3E}">
        <p14:creationId xmlns:p14="http://schemas.microsoft.com/office/powerpoint/2010/main" val="184207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12</TotalTime>
  <Words>610</Words>
  <Application>Microsoft Office PowerPoint</Application>
  <PresentationFormat>A4 용지(210x297mm)</PresentationFormat>
  <Paragraphs>47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윤석준</dc:creator>
  <cp:lastModifiedBy>eajeong</cp:lastModifiedBy>
  <cp:revision>226</cp:revision>
  <dcterms:created xsi:type="dcterms:W3CDTF">2024-12-19T07:01:18Z</dcterms:created>
  <dcterms:modified xsi:type="dcterms:W3CDTF">2025-11-27T09:11:53Z</dcterms:modified>
</cp:coreProperties>
</file>